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  <p:sldId id="266" r:id="rId4"/>
    <p:sldId id="267" r:id="rId5"/>
    <p:sldId id="268" r:id="rId6"/>
    <p:sldId id="259" r:id="rId7"/>
    <p:sldId id="260" r:id="rId8"/>
    <p:sldId id="261" r:id="rId9"/>
    <p:sldId id="262" r:id="rId10"/>
    <p:sldId id="263" r:id="rId11"/>
    <p:sldId id="264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48" d="100"/>
          <a:sy n="48" d="100"/>
        </p:scale>
        <p:origin x="6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FE5039-6FA9-422D-B7E4-F3172DBC1B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552523-A0C3-4D8F-A824-3749583959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8F7C58-BF89-4D82-B2FD-CC7288BE7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66B1AB-F8E3-429A-BBE2-E82F1330C6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6A026C-19BD-40AB-B62C-F8F3E570A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0113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4A7A9D-4C87-4490-8EDF-C50CD9CFC4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685F5D6-2A71-4868-980D-422F2DDE0E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087D23-C209-4B96-8CA2-56DD4F6A5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8E5C97-5559-48B7-BD84-B2937171A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9DC511-6637-4C3E-AC25-4ABA948E90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266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CDCEE8-C79C-459C-9B83-48774D5895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608585-FDA4-4510-AAAB-FAC32F8954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89AC5-9CD6-49B1-BDD6-FC793E393F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716B87-3823-4E3A-BBD9-BE475F30D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4D665-52D4-4AF1-83D8-5A14FD4A3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7811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CA6D8-10A8-4B0E-A79B-BD0ECB37FD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69AE63-B3A8-4675-B2AD-CB6F2DCD48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F41660-341D-4C49-9B3D-2199B2642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DAE872-85E2-4788-8E5B-C1A9E2C1D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185386-78C9-4F26-9436-CDB15F7847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080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25B8EC-3D48-42A8-A4B9-E56844144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BDE1BB-39E3-4FE1-A8E5-E4E53E13F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67A5CB-4636-427D-9B61-9624F64D4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A2B204-33C3-483A-9121-EC50AFFFE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169AE3-E5DA-4D3F-91D6-2242B707A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4225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35B09-0B25-43B1-B6D3-BBBAB0E4E3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CA5972-7629-4C7A-9863-69A72F976D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433325-FA0E-49FF-90C7-8FA97D0FA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BC1E67-2924-497D-9304-1FA06309E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AA7C84-43C2-4DF8-A944-9E851106E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ECC01F-382E-4EBD-8552-DE08A14D70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10074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75A76-10E9-4465-9B2E-B98AA84949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C1D2D2-2045-4F4D-8515-309226144C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E4E98D-9526-40B8-BC31-EFB5020EEC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17F0A2-D80D-4C50-9251-F83874C20D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B7C1BBD-76FA-4472-843F-B5199493BB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9D6C51-B335-4940-9959-220D057D9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DA552F-9460-4EF3-82EF-8474A56C7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33F5E1-3B5A-40A0-A3D1-EBD2253F5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049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DCD7D5-A7DB-4CD8-BDEE-8C6F145085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77AA30-A33A-4B39-AD88-BDEC52736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ED6D30-2569-4D31-9C78-5972BA354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F51D39-48EA-4AC6-B8BD-F6821D867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040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CB609B-B27B-4B47-B2C0-FEC8D344A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D96D9E-3ADF-40DF-9ABD-934660731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6293CE-1791-4C02-81C8-8C0A01D1E2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4413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57CCF-24B7-41AA-A853-C6BCCDC156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2CEA70-A150-4FA7-A0E4-D6961B1200C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2FA8C0-6253-41B2-BEC6-B58E418DB8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D22CB3-7BD5-401D-976B-40E1B6047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71C38B-A58B-42C7-B842-0688A1FD0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11537B-F748-4AAD-8E3F-A151AE5B4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4296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6B6D34-411E-442D-979A-8AA2039E66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3C47BF-15A2-4CAF-AF93-26EC1E99B8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E3B8B6-1FFC-4952-AF07-0993976F85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FC1DA2-5CCC-4500-A950-1FCDBB00B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D46363-FD87-4634-B1B0-0FBA57CBC2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E86512-EEB7-4E40-8B9D-6457B2F62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6839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725A07-3F23-4EDF-82B9-A0065DCDB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044E93-6A17-40E9-9186-F02A36FBD5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9664B5-81FA-4216-B071-91D90FC841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FF9B0-278D-4497-AC54-F676A240C7C8}" type="datetimeFigureOut">
              <a:rPr lang="en-GB" smtClean="0"/>
              <a:t>14/12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6E240A-01BE-450B-94CD-5C1CED67BD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97015-9255-42ED-86E9-4EEC6C532C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D5DBC-B877-476C-8833-F14545A0C93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566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CCE88ADD-846D-47E7-8F27-31175AF441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11349" y="1294773"/>
            <a:ext cx="9906000" cy="1655762"/>
          </a:xfrm>
        </p:spPr>
        <p:txBody>
          <a:bodyPr>
            <a:normAutofit lnSpcReduction="10000"/>
          </a:bodyPr>
          <a:lstStyle/>
          <a:p>
            <a:pPr algn="just"/>
            <a:r>
              <a:rPr lang="en-US" sz="1800" b="1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800" b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S4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. Assembly 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aphs for different assemblies from top performed assemblers. For short and long reads, </a:t>
            </a:r>
            <a:r>
              <a:rPr lang="en-GB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cycler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ye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formed best, respectively. For hybrid reads, </a:t>
            </a:r>
            <a:r>
              <a:rPr lang="en-GB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nicycler</a:t>
            </a:r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formed best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GFA files were used to construct the assembly graphs in Bandage.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The mixed culture was obtained from the co-culturing of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E. coli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4 and </a:t>
            </a:r>
            <a:r>
              <a:rPr lang="en-GB" sz="1800" i="1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K. pneumoniae </a:t>
            </a:r>
            <a:r>
              <a:rPr lang="en-GB" sz="18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5 isolates.</a:t>
            </a:r>
            <a:endParaRPr lang="nb-NO" sz="1800" dirty="0">
              <a:solidFill>
                <a:srgbClr val="000000"/>
              </a:solidFill>
              <a:latin typeface="Arial" panose="020B060402020202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GB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360191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Line chart&#10;&#10;Description automatically generated with medium confidence">
            <a:extLst>
              <a:ext uri="{FF2B5EF4-FFF2-40B4-BE49-F238E27FC236}">
                <a16:creationId xmlns:a16="http://schemas.microsoft.com/office/drawing/2014/main" id="{F7ECC436-4B04-4353-9859-0BC917FA06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440" y="1786072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A picture containing diagram&#10;&#10;Description automatically generated">
            <a:extLst>
              <a:ext uri="{FF2B5EF4-FFF2-40B4-BE49-F238E27FC236}">
                <a16:creationId xmlns:a16="http://schemas.microsoft.com/office/drawing/2014/main" id="{46D47B77-606F-4A19-9D62-B29A953C2E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289" y="1767211"/>
            <a:ext cx="3537345" cy="3298574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Shape, circle&#10;&#10;Description automatically generated">
            <a:extLst>
              <a:ext uri="{FF2B5EF4-FFF2-40B4-BE49-F238E27FC236}">
                <a16:creationId xmlns:a16="http://schemas.microsoft.com/office/drawing/2014/main" id="{3D6116B7-5042-4A62-ADE9-0FE773BF85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64DB5D71-962A-4A0A-9A0E-0C5D204A51FB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A786A2-5493-4C90-973F-E312D71A0BDD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2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7F1ACDA-3BF7-4C6B-A69D-695D38A7BEF9}"/>
              </a:ext>
            </a:extLst>
          </p:cNvPr>
          <p:cNvSpPr txBox="1"/>
          <p:nvPr/>
        </p:nvSpPr>
        <p:spPr>
          <a:xfrm>
            <a:off x="5011160" y="5511519"/>
            <a:ext cx="274626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118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B0846D-5B19-43E5-AC37-B81B4868BB15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</p:spTree>
    <p:extLst>
      <p:ext uri="{BB962C8B-B14F-4D97-AF65-F5344CB8AC3E}">
        <p14:creationId xmlns:p14="http://schemas.microsoft.com/office/powerpoint/2010/main" val="212984883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hape, circle&#10;&#10;Description automatically generated">
            <a:extLst>
              <a:ext uri="{FF2B5EF4-FFF2-40B4-BE49-F238E27FC236}">
                <a16:creationId xmlns:a16="http://schemas.microsoft.com/office/drawing/2014/main" id="{FF627267-91FF-42E7-A2B7-9A79E469F3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13041" y="1786071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3DB096A2-18C5-4233-A474-F6ACF6B08F8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840" y="1786071"/>
            <a:ext cx="3537345" cy="3298574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id="{BED699D3-35E7-4125-897D-9B984473FA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440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A785C85-3896-43E2-AB82-04D02B3297AC}"/>
              </a:ext>
            </a:extLst>
          </p:cNvPr>
          <p:cNvSpPr txBox="1"/>
          <p:nvPr/>
        </p:nvSpPr>
        <p:spPr>
          <a:xfrm>
            <a:off x="1050298" y="329772"/>
            <a:ext cx="1016303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dirty="0"/>
              <a:t>Mix sample of </a:t>
            </a:r>
            <a:r>
              <a:rPr lang="en-GB" sz="3600" b="1" i="1" dirty="0"/>
              <a:t>E. coli </a:t>
            </a:r>
            <a:r>
              <a:rPr lang="en-GB" sz="3600" b="1" dirty="0"/>
              <a:t>4 and </a:t>
            </a:r>
            <a:r>
              <a:rPr lang="en-GB" sz="3600" b="1" i="1" dirty="0"/>
              <a:t>K. pneumoniae </a:t>
            </a:r>
            <a:r>
              <a:rPr lang="en-GB" sz="3600" b="1" dirty="0"/>
              <a:t>5 isolat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EAB257-6B3C-4211-985D-5B954BE0D9D8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2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197A51C-2E42-4C06-A679-B7BB02E55A5A}"/>
              </a:ext>
            </a:extLst>
          </p:cNvPr>
          <p:cNvSpPr txBox="1"/>
          <p:nvPr/>
        </p:nvSpPr>
        <p:spPr>
          <a:xfrm>
            <a:off x="5069669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65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F886E3B-9AF1-436D-83B0-ED6504D83394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</a:t>
            </a:r>
            <a:r>
              <a:rPr lang="en-GB"/>
              <a:t>ends: 0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661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lamp&#10;&#10;Description automatically generated">
            <a:extLst>
              <a:ext uri="{FF2B5EF4-FFF2-40B4-BE49-F238E27FC236}">
                <a16:creationId xmlns:a16="http://schemas.microsoft.com/office/drawing/2014/main" id="{814DB827-9F63-4ED4-9606-BF00F19B804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9121" y="1786070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A picture containing necklet, accessory&#10;&#10;Description automatically generated">
            <a:extLst>
              <a:ext uri="{FF2B5EF4-FFF2-40B4-BE49-F238E27FC236}">
                <a16:creationId xmlns:a16="http://schemas.microsoft.com/office/drawing/2014/main" id="{63DA1451-B268-4CD1-A394-98A97E44A3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851" y="1786070"/>
            <a:ext cx="3537345" cy="3298574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A picture containing diagram&#10;&#10;Description automatically generated">
            <a:extLst>
              <a:ext uri="{FF2B5EF4-FFF2-40B4-BE49-F238E27FC236}">
                <a16:creationId xmlns:a16="http://schemas.microsoft.com/office/drawing/2014/main" id="{009E899F-A8BC-47B1-BED8-3CA71644648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2200" y="1786070"/>
            <a:ext cx="3517120" cy="327971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5383728-A8D8-4214-8FE4-659E126226C7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1CCB7F-B0BC-4E0F-9122-187D3129CD48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7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F011070-BBBC-4C28-A565-FE8B624E153A}"/>
              </a:ext>
            </a:extLst>
          </p:cNvPr>
          <p:cNvSpPr txBox="1"/>
          <p:nvPr/>
        </p:nvSpPr>
        <p:spPr>
          <a:xfrm>
            <a:off x="5069669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89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A215395-7D5F-4575-8FF1-B0465DE1D39E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3 </a:t>
            </a:r>
          </a:p>
        </p:txBody>
      </p:sp>
    </p:spTree>
    <p:extLst>
      <p:ext uri="{BB962C8B-B14F-4D97-AF65-F5344CB8AC3E}">
        <p14:creationId xmlns:p14="http://schemas.microsoft.com/office/powerpoint/2010/main" val="3548313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Icon&#10;&#10;Description automatically generated with medium confidence">
            <a:extLst>
              <a:ext uri="{FF2B5EF4-FFF2-40B4-BE49-F238E27FC236}">
                <a16:creationId xmlns:a16="http://schemas.microsoft.com/office/drawing/2014/main" id="{FAB63AA3-0F6B-45BE-89BB-785C6F9266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440" y="1786071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Chart, diagram&#10;&#10;Description automatically generated">
            <a:extLst>
              <a:ext uri="{FF2B5EF4-FFF2-40B4-BE49-F238E27FC236}">
                <a16:creationId xmlns:a16="http://schemas.microsoft.com/office/drawing/2014/main" id="{61968734-756F-4E46-A0C2-2538DCA2325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113" b="13853"/>
          <a:stretch/>
        </p:blipFill>
        <p:spPr>
          <a:xfrm>
            <a:off x="58910" y="2679031"/>
            <a:ext cx="4060193" cy="1997243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A picture containing necklet, accessory&#10;&#10;Description automatically generated">
            <a:extLst>
              <a:ext uri="{FF2B5EF4-FFF2-40B4-BE49-F238E27FC236}">
                <a16:creationId xmlns:a16="http://schemas.microsoft.com/office/drawing/2014/main" id="{92FE5A9D-D398-49A5-9FFE-366C7CDD575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0B50C5E-25AB-4F23-91C1-B37D1F28B709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4EBAAB8-2148-4934-A072-393EA832FB19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7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2138EB6-AC58-455D-BADE-BCAA4108CCBB}"/>
              </a:ext>
            </a:extLst>
          </p:cNvPr>
          <p:cNvSpPr txBox="1"/>
          <p:nvPr/>
        </p:nvSpPr>
        <p:spPr>
          <a:xfrm>
            <a:off x="5037609" y="5511519"/>
            <a:ext cx="269336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20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4B1883-E988-43DD-AF23-5677B345AC01}"/>
              </a:ext>
            </a:extLst>
          </p:cNvPr>
          <p:cNvSpPr txBox="1"/>
          <p:nvPr/>
        </p:nvSpPr>
        <p:spPr>
          <a:xfrm>
            <a:off x="9068353" y="5470539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3</a:t>
            </a:r>
          </a:p>
        </p:txBody>
      </p:sp>
    </p:spTree>
    <p:extLst>
      <p:ext uri="{BB962C8B-B14F-4D97-AF65-F5344CB8AC3E}">
        <p14:creationId xmlns:p14="http://schemas.microsoft.com/office/powerpoint/2010/main" val="40877185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icon&#10;&#10;Description automatically generated">
            <a:extLst>
              <a:ext uri="{FF2B5EF4-FFF2-40B4-BE49-F238E27FC236}">
                <a16:creationId xmlns:a16="http://schemas.microsoft.com/office/drawing/2014/main" id="{8C0951E6-213D-4E1D-90F4-F5D51CFBDF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440" y="1786071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Diagram&#10;&#10;Description automatically generated with low confidence">
            <a:extLst>
              <a:ext uri="{FF2B5EF4-FFF2-40B4-BE49-F238E27FC236}">
                <a16:creationId xmlns:a16="http://schemas.microsoft.com/office/drawing/2014/main" id="{F5DA2B67-2386-4C64-830F-684051E989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447" y="1786071"/>
            <a:ext cx="3537345" cy="3298574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0C1BACAE-B0E7-48B6-9A59-D68FB2AD607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EFE70CDB-85E9-4673-A2BD-A704B01134A1}"/>
              </a:ext>
            </a:extLst>
          </p:cNvPr>
          <p:cNvSpPr txBox="1"/>
          <p:nvPr/>
        </p:nvSpPr>
        <p:spPr>
          <a:xfrm>
            <a:off x="5213137" y="330818"/>
            <a:ext cx="18619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3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B279E73-662C-40E4-9455-4F35398C0949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BD7259B-C4AF-46BF-B1E9-EBAD4259C8D7}"/>
              </a:ext>
            </a:extLst>
          </p:cNvPr>
          <p:cNvSpPr txBox="1"/>
          <p:nvPr/>
        </p:nvSpPr>
        <p:spPr>
          <a:xfrm>
            <a:off x="5128178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4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4D1912-118B-40F7-9058-CCEC3B0602EE}"/>
              </a:ext>
            </a:extLst>
          </p:cNvPr>
          <p:cNvSpPr txBox="1"/>
          <p:nvPr/>
        </p:nvSpPr>
        <p:spPr>
          <a:xfrm>
            <a:off x="9068353" y="5470539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6</a:t>
            </a:r>
          </a:p>
        </p:txBody>
      </p:sp>
    </p:spTree>
    <p:extLst>
      <p:ext uri="{BB962C8B-B14F-4D97-AF65-F5344CB8AC3E}">
        <p14:creationId xmlns:p14="http://schemas.microsoft.com/office/powerpoint/2010/main" val="12998995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37B6167F-CB0E-4BC2-A3EC-1F50B63363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09121" y="1786069"/>
            <a:ext cx="3517119" cy="3279713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Chart&#10;&#10;Description automatically generated with medium confidence">
            <a:extLst>
              <a:ext uri="{FF2B5EF4-FFF2-40B4-BE49-F238E27FC236}">
                <a16:creationId xmlns:a16="http://schemas.microsoft.com/office/drawing/2014/main" id="{C2DC2E1D-FBB1-4F4D-9F5A-FD98CB2597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0676" y="2064049"/>
            <a:ext cx="3537345" cy="2723755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857A3152-3123-4275-B589-B8A4CCBB2C3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0" y="1786069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51D9D278-00C9-4C4D-8F12-8BE3C7D434E3}"/>
              </a:ext>
            </a:extLst>
          </p:cNvPr>
          <p:cNvSpPr txBox="1"/>
          <p:nvPr/>
        </p:nvSpPr>
        <p:spPr>
          <a:xfrm>
            <a:off x="5213137" y="330818"/>
            <a:ext cx="16850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E. coli </a:t>
            </a:r>
            <a:r>
              <a:rPr lang="en-GB" sz="3600" b="1" dirty="0"/>
              <a:t>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9583DC3-4A58-41D9-8707-F54D7798A097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DEE87C7-A9B3-441A-BDAA-9C9E1AE12D31}"/>
              </a:ext>
            </a:extLst>
          </p:cNvPr>
          <p:cNvSpPr txBox="1"/>
          <p:nvPr/>
        </p:nvSpPr>
        <p:spPr>
          <a:xfrm>
            <a:off x="5069669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10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4878555-9895-447E-AB90-9FB5330FAEC3}"/>
              </a:ext>
            </a:extLst>
          </p:cNvPr>
          <p:cNvSpPr txBox="1"/>
          <p:nvPr/>
        </p:nvSpPr>
        <p:spPr>
          <a:xfrm>
            <a:off x="9068353" y="5470539"/>
            <a:ext cx="24593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1 </a:t>
            </a:r>
          </a:p>
        </p:txBody>
      </p:sp>
    </p:spTree>
    <p:extLst>
      <p:ext uri="{BB962C8B-B14F-4D97-AF65-F5344CB8AC3E}">
        <p14:creationId xmlns:p14="http://schemas.microsoft.com/office/powerpoint/2010/main" val="38537227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Icon&#10;&#10;Description automatically generated with low confidence">
            <a:extLst>
              <a:ext uri="{FF2B5EF4-FFF2-40B4-BE49-F238E27FC236}">
                <a16:creationId xmlns:a16="http://schemas.microsoft.com/office/drawing/2014/main" id="{13245EB4-37CD-40C6-AF2D-B576F25C0B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7440" y="1671770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36041722-958F-43B8-81E2-D09E9DECB9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8895" y="1573887"/>
            <a:ext cx="3537345" cy="3298574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DC8D7F55-5B96-4607-A943-CD0EB9E612B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41" y="1516737"/>
            <a:ext cx="3517120" cy="327971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43DD58A-78B0-41F2-A2C7-33911ABA6476}"/>
              </a:ext>
            </a:extLst>
          </p:cNvPr>
          <p:cNvSpPr txBox="1"/>
          <p:nvPr/>
        </p:nvSpPr>
        <p:spPr>
          <a:xfrm>
            <a:off x="4395052" y="280737"/>
            <a:ext cx="36311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1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99850A-D9D4-4C9B-AF8D-D63D178C8190}"/>
              </a:ext>
            </a:extLst>
          </p:cNvPr>
          <p:cNvSpPr txBox="1"/>
          <p:nvPr/>
        </p:nvSpPr>
        <p:spPr>
          <a:xfrm>
            <a:off x="1060262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14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C5E0838-2F07-427E-A170-E9674F498CA3}"/>
              </a:ext>
            </a:extLst>
          </p:cNvPr>
          <p:cNvSpPr txBox="1"/>
          <p:nvPr/>
        </p:nvSpPr>
        <p:spPr>
          <a:xfrm>
            <a:off x="5069669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55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8E83BC9-E36E-41CB-BE09-DEDB8F8BBC46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5 </a:t>
            </a:r>
          </a:p>
        </p:txBody>
      </p:sp>
    </p:spTree>
    <p:extLst>
      <p:ext uri="{BB962C8B-B14F-4D97-AF65-F5344CB8AC3E}">
        <p14:creationId xmlns:p14="http://schemas.microsoft.com/office/powerpoint/2010/main" val="32979880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Shape, circle&#10;&#10;Description automatically generated">
            <a:extLst>
              <a:ext uri="{FF2B5EF4-FFF2-40B4-BE49-F238E27FC236}">
                <a16:creationId xmlns:a16="http://schemas.microsoft.com/office/drawing/2014/main" id="{A4E15B0D-730F-4382-9EE1-ABCEFB1A2D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735" y="1700346"/>
            <a:ext cx="3517119" cy="3279713"/>
          </a:xfrm>
          <a:prstGeom prst="rect">
            <a:avLst/>
          </a:prstGeom>
        </p:spPr>
      </p:pic>
      <p:cxnSp>
        <p:nvCxnSpPr>
          <p:cNvPr id="26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9FA6D051-DAB2-45ED-9A9E-84EC9D367D8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6722" y="1779713"/>
            <a:ext cx="3537345" cy="3298574"/>
          </a:xfrm>
          <a:prstGeom prst="rect">
            <a:avLst/>
          </a:prstGeom>
        </p:spPr>
      </p:pic>
      <p:cxnSp>
        <p:nvCxnSpPr>
          <p:cNvPr id="27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Shape, circle&#10;&#10;Description automatically generated">
            <a:extLst>
              <a:ext uri="{FF2B5EF4-FFF2-40B4-BE49-F238E27FC236}">
                <a16:creationId xmlns:a16="http://schemas.microsoft.com/office/drawing/2014/main" id="{1ED3465E-B81B-46AF-8D3B-A5E40362E80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8987" y="1700346"/>
            <a:ext cx="3517120" cy="3279714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CB7B7BF-2B26-4EF1-9AF5-DD2A8D5CA33C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D46572-A1AC-4DFD-8FF8-4C4446630EB0}"/>
              </a:ext>
            </a:extLst>
          </p:cNvPr>
          <p:cNvSpPr txBox="1"/>
          <p:nvPr/>
        </p:nvSpPr>
        <p:spPr>
          <a:xfrm>
            <a:off x="1060262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17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DCB5E90-6227-4BA2-AAE8-8D8B19957DEC}"/>
              </a:ext>
            </a:extLst>
          </p:cNvPr>
          <p:cNvSpPr txBox="1"/>
          <p:nvPr/>
        </p:nvSpPr>
        <p:spPr>
          <a:xfrm>
            <a:off x="5128179" y="5511519"/>
            <a:ext cx="25122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726238-F361-4860-AC6D-97EC12FD52A0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</p:spTree>
    <p:extLst>
      <p:ext uri="{BB962C8B-B14F-4D97-AF65-F5344CB8AC3E}">
        <p14:creationId xmlns:p14="http://schemas.microsoft.com/office/powerpoint/2010/main" val="1736590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Icon&#10;&#10;Description automatically generated">
            <a:extLst>
              <a:ext uri="{FF2B5EF4-FFF2-40B4-BE49-F238E27FC236}">
                <a16:creationId xmlns:a16="http://schemas.microsoft.com/office/drawing/2014/main" id="{73762656-1144-4FAE-B634-F988AFFFD1A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5593" y="1786072"/>
            <a:ext cx="3517119" cy="3279713"/>
          </a:xfrm>
          <a:prstGeom prst="rect">
            <a:avLst/>
          </a:prstGeom>
        </p:spPr>
      </p:pic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AD39D1F6-4492-496A-AE8D-2ABF86EEE98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185" y="1786071"/>
            <a:ext cx="3537345" cy="3298574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picture containing chart&#10;&#10;Description automatically generated">
            <a:extLst>
              <a:ext uri="{FF2B5EF4-FFF2-40B4-BE49-F238E27FC236}">
                <a16:creationId xmlns:a16="http://schemas.microsoft.com/office/drawing/2014/main" id="{D8CB6FAD-9539-489D-AF56-77B71282643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A6435BF-747D-4941-912F-C3D7590B05DA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3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382964-C42A-476B-A9CA-7E0ADC97601F}"/>
              </a:ext>
            </a:extLst>
          </p:cNvPr>
          <p:cNvSpPr txBox="1"/>
          <p:nvPr/>
        </p:nvSpPr>
        <p:spPr>
          <a:xfrm>
            <a:off x="1060262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11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F4DFE5-F650-464A-BCA4-7FDCE14CF033}"/>
              </a:ext>
            </a:extLst>
          </p:cNvPr>
          <p:cNvSpPr txBox="1"/>
          <p:nvPr/>
        </p:nvSpPr>
        <p:spPr>
          <a:xfrm>
            <a:off x="5128178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4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A5256E7-D1F7-4806-A3FE-E268982BE611}"/>
              </a:ext>
            </a:extLst>
          </p:cNvPr>
          <p:cNvSpPr txBox="1"/>
          <p:nvPr/>
        </p:nvSpPr>
        <p:spPr>
          <a:xfrm>
            <a:off x="9015455" y="5470539"/>
            <a:ext cx="25651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8 </a:t>
            </a:r>
          </a:p>
        </p:txBody>
      </p:sp>
    </p:spTree>
    <p:extLst>
      <p:ext uri="{BB962C8B-B14F-4D97-AF65-F5344CB8AC3E}">
        <p14:creationId xmlns:p14="http://schemas.microsoft.com/office/powerpoint/2010/main" val="171695566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Chart, line chart&#10;&#10;Description automatically generated">
            <a:extLst>
              <a:ext uri="{FF2B5EF4-FFF2-40B4-BE49-F238E27FC236}">
                <a16:creationId xmlns:a16="http://schemas.microsoft.com/office/drawing/2014/main" id="{37FA8F2B-56DF-472A-B667-2FEF972CB3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78" b="17991"/>
          <a:stretch/>
        </p:blipFill>
        <p:spPr>
          <a:xfrm>
            <a:off x="4196081" y="2366211"/>
            <a:ext cx="3571021" cy="2125578"/>
          </a:xfrm>
          <a:prstGeom prst="rect">
            <a:avLst/>
          </a:prstGeom>
        </p:spPr>
      </p:pic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CD67800-37AC-4E14-89B0-F79DCB3FB86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41656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CAA14653-3947-4FCE-BACE-1A2FEC0001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281" y="1786071"/>
            <a:ext cx="3537345" cy="3298574"/>
          </a:xfrm>
          <a:prstGeom prst="rect">
            <a:avLst/>
          </a:prstGeom>
        </p:spPr>
      </p:pic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0F1788F-A5AE-4188-8274-F7F2E3833ECD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CxnSpPr>
        <p:spPr>
          <a:xfrm>
            <a:off x="799592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Shape&#10;&#10;Description automatically generated with medium confidence">
            <a:extLst>
              <a:ext uri="{FF2B5EF4-FFF2-40B4-BE49-F238E27FC236}">
                <a16:creationId xmlns:a16="http://schemas.microsoft.com/office/drawing/2014/main" id="{4B6BDA23-5EF9-4093-82C7-73B0881ED9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62336" y="1786071"/>
            <a:ext cx="3517120" cy="327971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5F68B0B-D2D5-4AAC-9B99-F28214CE5AF1}"/>
              </a:ext>
            </a:extLst>
          </p:cNvPr>
          <p:cNvSpPr txBox="1"/>
          <p:nvPr/>
        </p:nvSpPr>
        <p:spPr>
          <a:xfrm>
            <a:off x="4395052" y="280737"/>
            <a:ext cx="3401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600" b="1" i="1" dirty="0"/>
              <a:t>K. pneumoniae </a:t>
            </a:r>
            <a:r>
              <a:rPr lang="en-GB" sz="3600" b="1" dirty="0"/>
              <a:t>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8E0070-6B39-4BC0-9F2C-8B41BADD3DB1}"/>
              </a:ext>
            </a:extLst>
          </p:cNvPr>
          <p:cNvSpPr txBox="1"/>
          <p:nvPr/>
        </p:nvSpPr>
        <p:spPr>
          <a:xfrm>
            <a:off x="1118771" y="551151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Illum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2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F611A8-02C2-48C7-88B8-AE5F3277AE62}"/>
              </a:ext>
            </a:extLst>
          </p:cNvPr>
          <p:cNvSpPr txBox="1"/>
          <p:nvPr/>
        </p:nvSpPr>
        <p:spPr>
          <a:xfrm>
            <a:off x="5069669" y="5511519"/>
            <a:ext cx="26292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MinION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Flye</a:t>
            </a:r>
            <a:endParaRPr lang="en-GB" dirty="0"/>
          </a:p>
          <a:p>
            <a:pPr algn="ctr"/>
            <a:r>
              <a:rPr lang="en-GB" dirty="0"/>
              <a:t>Number of dead ends: 43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77B724-8456-4AC6-B9E0-AA6063961839}"/>
              </a:ext>
            </a:extLst>
          </p:cNvPr>
          <p:cNvSpPr txBox="1"/>
          <p:nvPr/>
        </p:nvSpPr>
        <p:spPr>
          <a:xfrm>
            <a:off x="9041904" y="5470539"/>
            <a:ext cx="2512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 err="1"/>
              <a:t>Hyb</a:t>
            </a:r>
            <a:r>
              <a:rPr lang="en-GB" baseline="-25000" dirty="0" err="1"/>
              <a:t>ASM</a:t>
            </a:r>
            <a:r>
              <a:rPr lang="en-GB" dirty="0"/>
              <a:t> – </a:t>
            </a:r>
            <a:r>
              <a:rPr lang="en-GB" dirty="0" err="1"/>
              <a:t>Unicycler</a:t>
            </a:r>
            <a:endParaRPr lang="en-GB" dirty="0"/>
          </a:p>
          <a:p>
            <a:pPr algn="ctr"/>
            <a:r>
              <a:rPr lang="en-GB" dirty="0"/>
              <a:t>Number of dead ends: 0 </a:t>
            </a:r>
          </a:p>
        </p:txBody>
      </p:sp>
    </p:spTree>
    <p:extLst>
      <p:ext uri="{BB962C8B-B14F-4D97-AF65-F5344CB8AC3E}">
        <p14:creationId xmlns:p14="http://schemas.microsoft.com/office/powerpoint/2010/main" val="956434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390</Words>
  <Application>Microsoft Office PowerPoint</Application>
  <PresentationFormat>Widescreen</PresentationFormat>
  <Paragraphs>72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olrahman Khezri</dc:creator>
  <cp:lastModifiedBy>MDPI</cp:lastModifiedBy>
  <cp:revision>22</cp:revision>
  <dcterms:created xsi:type="dcterms:W3CDTF">2021-03-26T09:18:22Z</dcterms:created>
  <dcterms:modified xsi:type="dcterms:W3CDTF">2021-12-14T05:31:51Z</dcterms:modified>
</cp:coreProperties>
</file>